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29.wmf" ContentType="image/x-wmf"/>
  <Override PartName="/ppt/media/image6.png" ContentType="image/png"/>
  <Override PartName="/ppt/media/image10.png" ContentType="image/png"/>
  <Override PartName="/ppt/media/image28.wmf" ContentType="image/x-wmf"/>
  <Override PartName="/ppt/media/image5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F5373-4412-4FB8-A6B3-C8D1FACBBD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8BA41-6963-4BD6-B8CD-4A5BB0D983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2880EA-8C43-4585-A4E9-169F583430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FA3B17-6B0F-4DD9-ADD5-00704478CF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C0F24E-D074-44DC-8B19-BA5F90EEC5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F7F6D-FD91-4580-9B30-DDAB27E7EA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6643C8-7150-41AD-8700-FA17DA58DF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803DB-241E-4F78-BC5A-73B03019E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B84C1-F18E-432E-B7EC-E4C36A9401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B0D89-1CCC-4F26-803F-039331E1AB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9063E6-5B67-42E6-9404-61EB66B154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B2435-5FE8-4D30-BB8E-B58179482C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B627C6-7CEB-40E3-BD3C-9BE8E9A40A2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image" Target="../media/image20.png"/><Relationship Id="rId10" Type="http://schemas.openxmlformats.org/officeDocument/2006/relationships/image" Target="../media/image21.png"/><Relationship Id="rId11" Type="http://schemas.openxmlformats.org/officeDocument/2006/relationships/image" Target="../media/image22.png"/><Relationship Id="rId12" Type="http://schemas.openxmlformats.org/officeDocument/2006/relationships/image" Target="../media/image23.png"/><Relationship Id="rId13" Type="http://schemas.openxmlformats.org/officeDocument/2006/relationships/image" Target="../media/image24.png"/><Relationship Id="rId1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28.wmf"/><Relationship Id="rId6" Type="http://schemas.openxmlformats.org/officeDocument/2006/relationships/oleObject" Target="../embeddings/oleObject2.bin"/><Relationship Id="rId7" Type="http://schemas.openxmlformats.org/officeDocument/2006/relationships/image" Target="../media/image29.wmf"/><Relationship Id="rId8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직사각형 3"/>
          <p:cNvSpPr/>
          <p:nvPr/>
        </p:nvSpPr>
        <p:spPr>
          <a:xfrm>
            <a:off x="0" y="8532720"/>
            <a:ext cx="6858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 Unicode MS"/>
                <a:ea typeface="맑은 고딕"/>
              </a:rPr>
              <a:t>Supplementary Figure 1. cGAS-STING pathway in different stable cancer cell lin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2349360" y="324000"/>
            <a:ext cx="563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7"/>
          <p:cNvSpPr/>
          <p:nvPr/>
        </p:nvSpPr>
        <p:spPr>
          <a:xfrm>
            <a:off x="189000" y="324000"/>
            <a:ext cx="501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4" name="그룹 268"/>
          <p:cNvGrpSpPr/>
          <p:nvPr/>
        </p:nvGrpSpPr>
        <p:grpSpPr>
          <a:xfrm>
            <a:off x="194040" y="937440"/>
            <a:ext cx="2208240" cy="1834200"/>
            <a:chOff x="194040" y="937440"/>
            <a:chExt cx="2208240" cy="1834200"/>
          </a:xfrm>
        </p:grpSpPr>
        <p:pic>
          <p:nvPicPr>
            <p:cNvPr id="45" name="그림 269" descr=""/>
            <p:cNvPicPr/>
            <p:nvPr/>
          </p:nvPicPr>
          <p:blipFill>
            <a:blip r:embed="rId1"/>
            <a:stretch/>
          </p:blipFill>
          <p:spPr>
            <a:xfrm>
              <a:off x="889560" y="2411640"/>
              <a:ext cx="1439280" cy="36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그림 270" descr=""/>
            <p:cNvPicPr/>
            <p:nvPr/>
          </p:nvPicPr>
          <p:blipFill>
            <a:blip r:embed="rId2"/>
            <a:stretch/>
          </p:blipFill>
          <p:spPr>
            <a:xfrm>
              <a:off x="889560" y="1615680"/>
              <a:ext cx="1439280" cy="36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그림 271" descr=""/>
            <p:cNvPicPr/>
            <p:nvPr/>
          </p:nvPicPr>
          <p:blipFill>
            <a:blip r:embed="rId3"/>
            <a:stretch/>
          </p:blipFill>
          <p:spPr>
            <a:xfrm>
              <a:off x="889560" y="2013840"/>
              <a:ext cx="1439280" cy="36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직사각형 272"/>
            <p:cNvSpPr/>
            <p:nvPr/>
          </p:nvSpPr>
          <p:spPr>
            <a:xfrm>
              <a:off x="194040" y="2489760"/>
              <a:ext cx="677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직사각형 273"/>
            <p:cNvSpPr/>
            <p:nvPr/>
          </p:nvSpPr>
          <p:spPr>
            <a:xfrm>
              <a:off x="326520" y="1667520"/>
              <a:ext cx="546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cGA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직사각형 274"/>
            <p:cNvSpPr/>
            <p:nvPr/>
          </p:nvSpPr>
          <p:spPr>
            <a:xfrm>
              <a:off x="285120" y="2051640"/>
              <a:ext cx="60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TIN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직사각형 275"/>
            <p:cNvSpPr/>
            <p:nvPr/>
          </p:nvSpPr>
          <p:spPr>
            <a:xfrm rot="18351600">
              <a:off x="819720" y="1107720"/>
              <a:ext cx="6242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hTERT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RPE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직사각형 276"/>
            <p:cNvSpPr/>
            <p:nvPr/>
          </p:nvSpPr>
          <p:spPr>
            <a:xfrm rot="18360000">
              <a:off x="1223280" y="124308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U2O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직사각형 277"/>
            <p:cNvSpPr/>
            <p:nvPr/>
          </p:nvSpPr>
          <p:spPr>
            <a:xfrm rot="18360000">
              <a:off x="1919520" y="1276560"/>
              <a:ext cx="48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HeL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직사각형 278"/>
            <p:cNvSpPr/>
            <p:nvPr/>
          </p:nvSpPr>
          <p:spPr>
            <a:xfrm rot="18360000">
              <a:off x="1578600" y="127656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293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5" name="Group 29"/>
          <p:cNvGrpSpPr/>
          <p:nvPr/>
        </p:nvGrpSpPr>
        <p:grpSpPr>
          <a:xfrm>
            <a:off x="2928960" y="971640"/>
            <a:ext cx="3813120" cy="2225520"/>
            <a:chOff x="2928960" y="971640"/>
            <a:chExt cx="3813120" cy="2225520"/>
          </a:xfrm>
        </p:grpSpPr>
        <p:grpSp>
          <p:nvGrpSpPr>
            <p:cNvPr id="56" name="Group 28"/>
            <p:cNvGrpSpPr/>
            <p:nvPr/>
          </p:nvGrpSpPr>
          <p:grpSpPr>
            <a:xfrm>
              <a:off x="2928960" y="971640"/>
              <a:ext cx="3813120" cy="1073520"/>
              <a:chOff x="2928960" y="971640"/>
              <a:chExt cx="3813120" cy="1073520"/>
            </a:xfrm>
          </p:grpSpPr>
          <p:pic>
            <p:nvPicPr>
              <p:cNvPr id="57" name="그림 9" descr=""/>
              <p:cNvPicPr/>
              <p:nvPr/>
            </p:nvPicPr>
            <p:blipFill>
              <a:blip r:embed="rId4"/>
              <a:srcRect l="42963" t="25197" r="935" b="46723"/>
              <a:stretch/>
            </p:blipFill>
            <p:spPr>
              <a:xfrm>
                <a:off x="2928960" y="971640"/>
                <a:ext cx="3813120" cy="1073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TextBox 22"/>
              <p:cNvSpPr/>
              <p:nvPr/>
            </p:nvSpPr>
            <p:spPr>
              <a:xfrm>
                <a:off x="6282000" y="1706760"/>
                <a:ext cx="448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ff00"/>
                    </a:solidFill>
                    <a:latin typeface="Arial"/>
                    <a:ea typeface="맑은 고딕"/>
                  </a:rPr>
                  <a:t>cGA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70c0"/>
                    </a:solidFill>
                    <a:latin typeface="Arial"/>
                    <a:ea typeface="맑은 고딕"/>
                  </a:rPr>
                  <a:t>DAP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9" name="Group 27"/>
            <p:cNvGrpSpPr/>
            <p:nvPr/>
          </p:nvGrpSpPr>
          <p:grpSpPr>
            <a:xfrm>
              <a:off x="2928960" y="2123640"/>
              <a:ext cx="3813120" cy="1073520"/>
              <a:chOff x="2928960" y="2123640"/>
              <a:chExt cx="3813120" cy="1073520"/>
            </a:xfrm>
          </p:grpSpPr>
          <p:pic>
            <p:nvPicPr>
              <p:cNvPr id="60" name="그림 8" descr=""/>
              <p:cNvPicPr/>
              <p:nvPr/>
            </p:nvPicPr>
            <p:blipFill>
              <a:blip r:embed="rId5"/>
              <a:srcRect l="42931" t="25116" r="968" b="46812"/>
              <a:stretch/>
            </p:blipFill>
            <p:spPr>
              <a:xfrm>
                <a:off x="2928960" y="2123640"/>
                <a:ext cx="3813120" cy="1073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" name="TextBox 21"/>
              <p:cNvSpPr/>
              <p:nvPr/>
            </p:nvSpPr>
            <p:spPr>
              <a:xfrm>
                <a:off x="6282000" y="2858760"/>
                <a:ext cx="448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ff00"/>
                    </a:solidFill>
                    <a:latin typeface="Arial"/>
                    <a:ea typeface="맑은 고딕"/>
                  </a:rPr>
                  <a:t>cGA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70c0"/>
                    </a:solidFill>
                    <a:latin typeface="Arial"/>
                    <a:ea typeface="맑은 고딕"/>
                  </a:rPr>
                  <a:t>DAP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Isosceles Triangle 23"/>
              <p:cNvSpPr/>
              <p:nvPr/>
            </p:nvSpPr>
            <p:spPr>
              <a:xfrm flipH="1" rot="15660000">
                <a:off x="6226920" y="2436120"/>
                <a:ext cx="107640" cy="11736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Isosceles Triangle 24"/>
              <p:cNvSpPr/>
              <p:nvPr/>
            </p:nvSpPr>
            <p:spPr>
              <a:xfrm flipH="1" rot="1860000">
                <a:off x="5668560" y="2688840"/>
                <a:ext cx="107640" cy="117360"/>
              </a:xfrm>
              <a:prstGeom prst="triangle">
                <a:avLst>
                  <a:gd name="adj" fmla="val 50000"/>
                </a:avLst>
              </a:prstGeom>
              <a:solidFill>
                <a:srgbClr val="ffff00"/>
              </a:solidFill>
              <a:ln w="2556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64" name="TextBox 26"/>
          <p:cNvSpPr/>
          <p:nvPr/>
        </p:nvSpPr>
        <p:spPr>
          <a:xfrm rot="16200000">
            <a:off x="2186640" y="2460960"/>
            <a:ext cx="1073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Nocodazo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release / 8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0"/>
          <p:cNvSpPr/>
          <p:nvPr/>
        </p:nvSpPr>
        <p:spPr>
          <a:xfrm rot="16200000">
            <a:off x="2264400" y="1384560"/>
            <a:ext cx="107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Asynchronou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Chart 32" descr=""/>
          <p:cNvPicPr/>
          <p:nvPr/>
        </p:nvPicPr>
        <p:blipFill>
          <a:blip r:embed="rId6"/>
          <a:stretch/>
        </p:blipFill>
        <p:spPr>
          <a:xfrm>
            <a:off x="60480" y="4211640"/>
            <a:ext cx="3730320" cy="2743200"/>
          </a:xfrm>
          <a:prstGeom prst="rect">
            <a:avLst/>
          </a:prstGeom>
          <a:ln w="0">
            <a:noFill/>
          </a:ln>
        </p:spPr>
      </p:pic>
      <p:sp>
        <p:nvSpPr>
          <p:cNvPr id="67" name="TextBox 33"/>
          <p:cNvSpPr/>
          <p:nvPr/>
        </p:nvSpPr>
        <p:spPr>
          <a:xfrm>
            <a:off x="157320" y="3708360"/>
            <a:ext cx="56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4"/>
          <p:cNvSpPr/>
          <p:nvPr/>
        </p:nvSpPr>
        <p:spPr>
          <a:xfrm>
            <a:off x="3716280" y="3708360"/>
            <a:ext cx="565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1"/>
          <p:cNvSpPr/>
          <p:nvPr/>
        </p:nvSpPr>
        <p:spPr>
          <a:xfrm>
            <a:off x="736560" y="5370480"/>
            <a:ext cx="3794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36"/>
          <p:cNvSpPr/>
          <p:nvPr/>
        </p:nvSpPr>
        <p:spPr>
          <a:xfrm>
            <a:off x="722160" y="5580000"/>
            <a:ext cx="409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"/>
          <p:cNvSpPr/>
          <p:nvPr/>
        </p:nvSpPr>
        <p:spPr>
          <a:xfrm>
            <a:off x="1571760" y="4716360"/>
            <a:ext cx="377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39"/>
          <p:cNvSpPr/>
          <p:nvPr/>
        </p:nvSpPr>
        <p:spPr>
          <a:xfrm>
            <a:off x="1557360" y="4925880"/>
            <a:ext cx="409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"/>
          <p:cNvSpPr/>
          <p:nvPr/>
        </p:nvSpPr>
        <p:spPr>
          <a:xfrm>
            <a:off x="2386080" y="4211640"/>
            <a:ext cx="377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41"/>
          <p:cNvSpPr/>
          <p:nvPr/>
        </p:nvSpPr>
        <p:spPr>
          <a:xfrm>
            <a:off x="2370240" y="4421160"/>
            <a:ext cx="41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1"/>
          <p:cNvSpPr/>
          <p:nvPr/>
        </p:nvSpPr>
        <p:spPr>
          <a:xfrm>
            <a:off x="3156120" y="4932360"/>
            <a:ext cx="377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traight Connector 43"/>
          <p:cNvSpPr/>
          <p:nvPr/>
        </p:nvSpPr>
        <p:spPr>
          <a:xfrm>
            <a:off x="3141720" y="5141880"/>
            <a:ext cx="409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" name="Group 59"/>
          <p:cNvGrpSpPr/>
          <p:nvPr/>
        </p:nvGrpSpPr>
        <p:grpSpPr>
          <a:xfrm>
            <a:off x="4478400" y="3059280"/>
            <a:ext cx="1398600" cy="3581280"/>
            <a:chOff x="4478400" y="3059280"/>
            <a:chExt cx="1398600" cy="3581280"/>
          </a:xfrm>
        </p:grpSpPr>
        <p:grpSp>
          <p:nvGrpSpPr>
            <p:cNvPr id="78" name="Group 60"/>
            <p:cNvGrpSpPr/>
            <p:nvPr/>
          </p:nvGrpSpPr>
          <p:grpSpPr>
            <a:xfrm>
              <a:off x="4478400" y="4240080"/>
              <a:ext cx="1398600" cy="2400480"/>
              <a:chOff x="4478400" y="4240080"/>
              <a:chExt cx="1398600" cy="2400480"/>
            </a:xfrm>
          </p:grpSpPr>
          <p:pic>
            <p:nvPicPr>
              <p:cNvPr id="79" name="그림 38" descr=""/>
              <p:cNvPicPr/>
              <p:nvPr/>
            </p:nvPicPr>
            <p:blipFill>
              <a:blip r:embed="rId7"/>
              <a:stretch/>
            </p:blipFill>
            <p:spPr>
              <a:xfrm>
                <a:off x="5164200" y="4240080"/>
                <a:ext cx="712800" cy="291960"/>
              </a:xfrm>
              <a:prstGeom prst="rect">
                <a:avLst/>
              </a:prstGeom>
              <a:ln w="9360">
                <a:solidFill>
                  <a:srgbClr val="404040"/>
                </a:solidFill>
                <a:miter/>
              </a:ln>
            </p:spPr>
          </p:pic>
          <p:pic>
            <p:nvPicPr>
              <p:cNvPr id="80" name="그림 39" descr=""/>
              <p:cNvPicPr/>
              <p:nvPr/>
            </p:nvPicPr>
            <p:blipFill>
              <a:blip r:embed="rId8"/>
              <a:stretch/>
            </p:blipFill>
            <p:spPr>
              <a:xfrm>
                <a:off x="5164200" y="4595400"/>
                <a:ext cx="712800" cy="291960"/>
              </a:xfrm>
              <a:prstGeom prst="rect">
                <a:avLst/>
              </a:prstGeom>
              <a:ln w="9360">
                <a:solidFill>
                  <a:srgbClr val="404040"/>
                </a:solidFill>
                <a:miter/>
              </a:ln>
            </p:spPr>
          </p:pic>
          <p:pic>
            <p:nvPicPr>
              <p:cNvPr id="81" name="그림 42" descr=""/>
              <p:cNvPicPr/>
              <p:nvPr/>
            </p:nvPicPr>
            <p:blipFill>
              <a:blip r:embed="rId9"/>
              <a:stretch/>
            </p:blipFill>
            <p:spPr>
              <a:xfrm>
                <a:off x="5164200" y="6348600"/>
                <a:ext cx="712800" cy="291960"/>
              </a:xfrm>
              <a:prstGeom prst="rect">
                <a:avLst/>
              </a:prstGeom>
              <a:ln w="9360">
                <a:solidFill>
                  <a:srgbClr val="404040"/>
                </a:solidFill>
                <a:miter/>
              </a:ln>
            </p:spPr>
          </p:pic>
          <p:sp>
            <p:nvSpPr>
              <p:cNvPr id="82" name="직사각형 43"/>
              <p:cNvSpPr/>
              <p:nvPr/>
            </p:nvSpPr>
            <p:spPr>
              <a:xfrm>
                <a:off x="4606560" y="4255200"/>
                <a:ext cx="546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cGAS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직사각형 44"/>
              <p:cNvSpPr/>
              <p:nvPr/>
            </p:nvSpPr>
            <p:spPr>
              <a:xfrm>
                <a:off x="4547880" y="5634720"/>
                <a:ext cx="6091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p-IRF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직사각형 45"/>
              <p:cNvSpPr/>
              <p:nvPr/>
            </p:nvSpPr>
            <p:spPr>
              <a:xfrm>
                <a:off x="4505040" y="4939560"/>
                <a:ext cx="654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p-TBK1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직사각형 46"/>
              <p:cNvSpPr/>
              <p:nvPr/>
            </p:nvSpPr>
            <p:spPr>
              <a:xfrm>
                <a:off x="4551840" y="4610160"/>
                <a:ext cx="6091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STIN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직사각형 47"/>
              <p:cNvSpPr/>
              <p:nvPr/>
            </p:nvSpPr>
            <p:spPr>
              <a:xfrm>
                <a:off x="4478400" y="6364440"/>
                <a:ext cx="6775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GAPDH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87" name="그림 97" descr=""/>
              <p:cNvPicPr/>
              <p:nvPr/>
            </p:nvPicPr>
            <p:blipFill>
              <a:blip r:embed="rId10"/>
              <a:srcRect l="78644" t="0" r="0" b="0"/>
              <a:stretch/>
            </p:blipFill>
            <p:spPr>
              <a:xfrm flipH="1">
                <a:off x="5164200" y="4924080"/>
                <a:ext cx="712800" cy="2923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88" name="그림 98" descr=""/>
              <p:cNvPicPr/>
              <p:nvPr/>
            </p:nvPicPr>
            <p:blipFill>
              <a:blip r:embed="rId11"/>
              <a:srcRect l="77702" t="50058" r="0" b="0"/>
              <a:stretch/>
            </p:blipFill>
            <p:spPr>
              <a:xfrm flipH="1">
                <a:off x="5164200" y="5618880"/>
                <a:ext cx="712800" cy="2923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89" name="그림 45" descr=""/>
              <p:cNvPicPr/>
              <p:nvPr/>
            </p:nvPicPr>
            <p:blipFill>
              <a:blip r:embed="rId12"/>
              <a:srcRect l="29728" t="0" r="26177" b="0"/>
              <a:stretch/>
            </p:blipFill>
            <p:spPr>
              <a:xfrm>
                <a:off x="5164200" y="5281560"/>
                <a:ext cx="712800" cy="293400"/>
              </a:xfrm>
              <a:prstGeom prst="rect">
                <a:avLst/>
              </a:prstGeom>
              <a:ln w="9360">
                <a:solidFill>
                  <a:srgbClr val="404040"/>
                </a:solidFill>
                <a:miter/>
              </a:ln>
            </p:spPr>
          </p:pic>
          <p:pic>
            <p:nvPicPr>
              <p:cNvPr id="90" name="그림 46" descr=""/>
              <p:cNvPicPr/>
              <p:nvPr/>
            </p:nvPicPr>
            <p:blipFill>
              <a:blip r:embed="rId13"/>
              <a:srcRect l="29724" t="0" r="26177" b="0"/>
              <a:stretch/>
            </p:blipFill>
            <p:spPr>
              <a:xfrm>
                <a:off x="5164200" y="5997600"/>
                <a:ext cx="712800" cy="291960"/>
              </a:xfrm>
              <a:prstGeom prst="rect">
                <a:avLst/>
              </a:prstGeom>
              <a:ln w="9360">
                <a:solidFill>
                  <a:srgbClr val="404040"/>
                </a:solidFill>
                <a:miter/>
              </a:ln>
            </p:spPr>
          </p:pic>
          <p:sp>
            <p:nvSpPr>
              <p:cNvPr id="91" name="직사각형 46"/>
              <p:cNvSpPr/>
              <p:nvPr/>
            </p:nvSpPr>
            <p:spPr>
              <a:xfrm>
                <a:off x="4677120" y="6012360"/>
                <a:ext cx="483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IRF3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직사각형 46"/>
              <p:cNvSpPr/>
              <p:nvPr/>
            </p:nvSpPr>
            <p:spPr>
              <a:xfrm>
                <a:off x="4629960" y="5297760"/>
                <a:ext cx="5295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TBK1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3" name="TextBox 61"/>
            <p:cNvSpPr/>
            <p:nvPr/>
          </p:nvSpPr>
          <p:spPr>
            <a:xfrm rot="16200000">
              <a:off x="4755960" y="3435120"/>
              <a:ext cx="11808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Non-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transfecte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62"/>
            <p:cNvSpPr/>
            <p:nvPr/>
          </p:nvSpPr>
          <p:spPr>
            <a:xfrm rot="16200000">
              <a:off x="5094720" y="3519000"/>
              <a:ext cx="1180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pcD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"/>
          <p:cNvSpPr txBox="1"/>
          <p:nvPr/>
        </p:nvSpPr>
        <p:spPr>
          <a:xfrm>
            <a:off x="342720" y="409320"/>
            <a:ext cx="6172200" cy="3801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algn="just">
              <a:lnSpc>
                <a:spcPct val="2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: cGAS-STING pathway in different stable cancer cell lines.    (a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Protein expression levels were analyzed by western blot using antibodies against cGAS, STING &amp; GAPDH in hTERT-RPE1, U2OS, HEK293T &amp; HeLa cells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Representative confocal images of cGAS localized micronuclei (yellow arrow head) and micronuclei without cGAS localization (white arrow head) 10 h after release from nocodazole (100ng/ml) treatment for 16 h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(c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ercentage of cells showing cGAS positive micronuclei and cGAS negative micronuclei after 10 h release from nocodazole treatment in HeLa, U2OS, hTERT-RPE1 &amp; HEK293T cells. The results are given as the mean ± SD from three independent experiments (n = 300). ***P &lt; 0.001 by Student’s t-test.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(d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cGAS-STING pathway activation after pcDNA transfection was analyzed in HeLa cells by western blot using antibodies against cGAS, STING, phospho-TBK1, TBK1, phospho-IRF3, IRF3 &amp; GAPDH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직사각형 3"/>
          <p:cNvSpPr/>
          <p:nvPr/>
        </p:nvSpPr>
        <p:spPr>
          <a:xfrm>
            <a:off x="0" y="8532720"/>
            <a:ext cx="6858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 Unicode MS"/>
                <a:ea typeface="맑은 고딕"/>
              </a:rPr>
              <a:t>Supplementary Figure 2.  cGAS-STING pathway does not affect centrosome amplification or DNA damag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7" name="Group 30"/>
          <p:cNvGrpSpPr/>
          <p:nvPr/>
        </p:nvGrpSpPr>
        <p:grpSpPr>
          <a:xfrm>
            <a:off x="109440" y="387360"/>
            <a:ext cx="6575400" cy="3494520"/>
            <a:chOff x="109440" y="387360"/>
            <a:chExt cx="6575400" cy="3494520"/>
          </a:xfrm>
        </p:grpSpPr>
        <p:grpSp>
          <p:nvGrpSpPr>
            <p:cNvPr id="98" name="Group 22"/>
            <p:cNvGrpSpPr/>
            <p:nvPr/>
          </p:nvGrpSpPr>
          <p:grpSpPr>
            <a:xfrm>
              <a:off x="109440" y="387360"/>
              <a:ext cx="6575400" cy="3365640"/>
              <a:chOff x="109440" y="387360"/>
              <a:chExt cx="6575400" cy="3365640"/>
            </a:xfrm>
          </p:grpSpPr>
          <p:sp>
            <p:nvSpPr>
              <p:cNvPr id="99" name="TextBox 5"/>
              <p:cNvSpPr/>
              <p:nvPr/>
            </p:nvSpPr>
            <p:spPr>
              <a:xfrm>
                <a:off x="3859920" y="387360"/>
                <a:ext cx="5644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 Unicode MS"/>
                  </a:rPr>
                  <a:t>b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TextBox 7"/>
              <p:cNvSpPr/>
              <p:nvPr/>
            </p:nvSpPr>
            <p:spPr>
              <a:xfrm>
                <a:off x="109440" y="725400"/>
                <a:ext cx="502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 Unicode MS"/>
                  </a:rPr>
                  <a:t>a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01" name="Group 2"/>
              <p:cNvGrpSpPr/>
              <p:nvPr/>
            </p:nvGrpSpPr>
            <p:grpSpPr>
              <a:xfrm>
                <a:off x="109440" y="1284120"/>
                <a:ext cx="3812400" cy="1269720"/>
                <a:chOff x="109440" y="1284120"/>
                <a:chExt cx="3812400" cy="1269720"/>
              </a:xfrm>
            </p:grpSpPr>
            <p:grpSp>
              <p:nvGrpSpPr>
                <p:cNvPr id="102" name="Group 1"/>
                <p:cNvGrpSpPr/>
                <p:nvPr/>
              </p:nvGrpSpPr>
              <p:grpSpPr>
                <a:xfrm>
                  <a:off x="109440" y="1284120"/>
                  <a:ext cx="3812400" cy="1269720"/>
                  <a:chOff x="109440" y="1284120"/>
                  <a:chExt cx="3812400" cy="1269720"/>
                </a:xfrm>
              </p:grpSpPr>
              <p:pic>
                <p:nvPicPr>
                  <p:cNvPr id="103" name="그림 3" descr=""/>
                  <p:cNvPicPr/>
                  <p:nvPr/>
                </p:nvPicPr>
                <p:blipFill>
                  <a:blip r:embed="rId1"/>
                  <a:srcRect l="24247" t="22709" r="57007" b="44344"/>
                  <a:stretch/>
                </p:blipFill>
                <p:spPr>
                  <a:xfrm>
                    <a:off x="109440" y="1284120"/>
                    <a:ext cx="1270800" cy="1269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04" name="그림 5" descr=""/>
                  <p:cNvPicPr/>
                  <p:nvPr/>
                </p:nvPicPr>
                <p:blipFill>
                  <a:blip r:embed="rId2"/>
                  <a:srcRect l="61723" t="22709" r="775" b="44344"/>
                  <a:stretch/>
                </p:blipFill>
                <p:spPr>
                  <a:xfrm>
                    <a:off x="1380240" y="1284120"/>
                    <a:ext cx="2541600" cy="1269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105" name="TextBox 11"/>
                <p:cNvSpPr/>
                <p:nvPr/>
              </p:nvSpPr>
              <p:spPr>
                <a:xfrm>
                  <a:off x="3338640" y="1284120"/>
                  <a:ext cx="572400" cy="398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ff0000"/>
                      </a:solidFill>
                      <a:latin typeface="Arial"/>
                      <a:ea typeface="맑은 고딕"/>
                    </a:rPr>
                    <a:t>ᵞ</a:t>
                  </a:r>
                  <a:r>
                    <a:rPr b="0" lang="en-US" sz="1200" spc="-1" strike="noStrike">
                      <a:solidFill>
                        <a:srgbClr val="ff0000"/>
                      </a:solidFill>
                      <a:latin typeface="Arial"/>
                      <a:ea typeface="맑은 고딕"/>
                    </a:rPr>
                    <a:t>-</a:t>
                  </a:r>
                  <a:r>
                    <a:rPr b="0" lang="en-US" sz="800" spc="-1" strike="noStrike">
                      <a:solidFill>
                        <a:srgbClr val="ff0000"/>
                      </a:solidFill>
                      <a:latin typeface="Arial"/>
                      <a:ea typeface="맑은 고딕"/>
                    </a:rPr>
                    <a:t>tubulin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70c0"/>
                      </a:solidFill>
                      <a:latin typeface="Arial"/>
                      <a:ea typeface="맑은 고딕"/>
                    </a:rPr>
                    <a:t>DAPI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06" name="Isosceles Triangle 12"/>
              <p:cNvSpPr/>
              <p:nvPr/>
            </p:nvSpPr>
            <p:spPr>
              <a:xfrm flipH="1" rot="21060000">
                <a:off x="2054520" y="2180160"/>
                <a:ext cx="107640" cy="11736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Isosceles Triangle 13"/>
              <p:cNvSpPr/>
              <p:nvPr/>
            </p:nvSpPr>
            <p:spPr>
              <a:xfrm flipH="1" flipV="1" rot="21060000">
                <a:off x="1928520" y="1374480"/>
                <a:ext cx="107640" cy="11736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08" name="Chart 14" descr=""/>
              <p:cNvPicPr/>
              <p:nvPr/>
            </p:nvPicPr>
            <p:blipFill>
              <a:blip r:embed="rId3"/>
              <a:stretch/>
            </p:blipFill>
            <p:spPr>
              <a:xfrm>
                <a:off x="3936600" y="725040"/>
                <a:ext cx="2748240" cy="30279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09" name="Straight Connector 6"/>
            <p:cNvSpPr/>
            <p:nvPr/>
          </p:nvSpPr>
          <p:spPr>
            <a:xfrm flipH="1">
              <a:off x="5662080" y="3635640"/>
              <a:ext cx="86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Straight Connector 27"/>
            <p:cNvSpPr/>
            <p:nvPr/>
          </p:nvSpPr>
          <p:spPr>
            <a:xfrm flipH="1">
              <a:off x="4652640" y="3635640"/>
              <a:ext cx="86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19"/>
            <p:cNvSpPr/>
            <p:nvPr/>
          </p:nvSpPr>
          <p:spPr>
            <a:xfrm>
              <a:off x="4653360" y="363564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iC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29"/>
            <p:cNvSpPr/>
            <p:nvPr/>
          </p:nvSpPr>
          <p:spPr>
            <a:xfrm>
              <a:off x="5661720" y="363564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iSTIN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3" name="Group 8"/>
          <p:cNvGrpSpPr/>
          <p:nvPr/>
        </p:nvGrpSpPr>
        <p:grpSpPr>
          <a:xfrm>
            <a:off x="76320" y="4191120"/>
            <a:ext cx="3555720" cy="3639960"/>
            <a:chOff x="76320" y="4191120"/>
            <a:chExt cx="3555720" cy="3639960"/>
          </a:xfrm>
        </p:grpSpPr>
        <p:grpSp>
          <p:nvGrpSpPr>
            <p:cNvPr id="114" name="Group 54"/>
            <p:cNvGrpSpPr/>
            <p:nvPr/>
          </p:nvGrpSpPr>
          <p:grpSpPr>
            <a:xfrm>
              <a:off x="476640" y="4754520"/>
              <a:ext cx="3155400" cy="3076560"/>
              <a:chOff x="476640" y="4754520"/>
              <a:chExt cx="3155400" cy="3076560"/>
            </a:xfrm>
          </p:grpSpPr>
          <p:grpSp>
            <p:nvGrpSpPr>
              <p:cNvPr id="115" name="Group 55"/>
              <p:cNvGrpSpPr/>
              <p:nvPr/>
            </p:nvGrpSpPr>
            <p:grpSpPr>
              <a:xfrm>
                <a:off x="476640" y="4754520"/>
                <a:ext cx="1024200" cy="3076560"/>
                <a:chOff x="476640" y="4754520"/>
                <a:chExt cx="1024200" cy="3076560"/>
              </a:xfrm>
            </p:grpSpPr>
            <p:pic>
              <p:nvPicPr>
                <p:cNvPr id="116" name="Picture 2" descr=""/>
                <p:cNvPicPr/>
                <p:nvPr/>
              </p:nvPicPr>
              <p:blipFill>
                <a:blip r:embed="rId4"/>
                <a:srcRect l="6444" t="32295" r="63839" b="31468"/>
                <a:stretch/>
              </p:blipFill>
              <p:spPr>
                <a:xfrm>
                  <a:off x="476640" y="4754520"/>
                  <a:ext cx="1024200" cy="1024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7" name="Picture 2" descr=""/>
                <p:cNvPicPr/>
                <p:nvPr/>
              </p:nvPicPr>
              <p:blipFill>
                <a:blip r:embed="rId5"/>
                <a:srcRect l="37490" t="32303" r="32803" b="29997"/>
                <a:stretch/>
              </p:blipFill>
              <p:spPr>
                <a:xfrm>
                  <a:off x="476640" y="5790960"/>
                  <a:ext cx="1024200" cy="10094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8" name="Picture 2" descr=""/>
                <p:cNvPicPr/>
                <p:nvPr/>
              </p:nvPicPr>
              <p:blipFill>
                <a:blip r:embed="rId6"/>
                <a:srcRect l="67939" t="31876" r="2343" b="30211"/>
                <a:stretch/>
              </p:blipFill>
              <p:spPr>
                <a:xfrm>
                  <a:off x="476640" y="6806880"/>
                  <a:ext cx="1024200" cy="10242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pic>
            <p:nvPicPr>
              <p:cNvPr id="119" name="Picture 2" descr=""/>
              <p:cNvPicPr/>
              <p:nvPr/>
            </p:nvPicPr>
            <p:blipFill>
              <a:blip r:embed="rId7"/>
              <a:srcRect l="67946" t="32084" r="2191" b="30211"/>
              <a:stretch/>
            </p:blipFill>
            <p:spPr>
              <a:xfrm>
                <a:off x="1543320" y="6806880"/>
                <a:ext cx="1024200" cy="1024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0" name="Picture 2" descr=""/>
              <p:cNvPicPr/>
              <p:nvPr/>
            </p:nvPicPr>
            <p:blipFill>
              <a:blip r:embed="rId8"/>
              <a:srcRect l="6438" t="32084" r="63699" b="30211"/>
              <a:stretch/>
            </p:blipFill>
            <p:spPr>
              <a:xfrm>
                <a:off x="1543320" y="4754520"/>
                <a:ext cx="1024200" cy="1024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1" name="Picture 2" descr=""/>
              <p:cNvPicPr/>
              <p:nvPr/>
            </p:nvPicPr>
            <p:blipFill>
              <a:blip r:embed="rId9"/>
              <a:srcRect l="37014" t="32090" r="33124" b="30211"/>
              <a:stretch/>
            </p:blipFill>
            <p:spPr>
              <a:xfrm>
                <a:off x="1543320" y="5797080"/>
                <a:ext cx="1024200" cy="1009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2" name="Picture 2" descr=""/>
              <p:cNvPicPr/>
              <p:nvPr/>
            </p:nvPicPr>
            <p:blipFill>
              <a:blip r:embed="rId10"/>
              <a:srcRect l="37014" t="32088" r="32415" b="30415"/>
              <a:stretch/>
            </p:blipFill>
            <p:spPr>
              <a:xfrm>
                <a:off x="2607840" y="5797080"/>
                <a:ext cx="1024200" cy="1009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3" name="Picture 2" descr=""/>
              <p:cNvPicPr/>
              <p:nvPr/>
            </p:nvPicPr>
            <p:blipFill>
              <a:blip r:embed="rId11"/>
              <a:srcRect l="6443" t="32090" r="63232" b="30415"/>
              <a:stretch/>
            </p:blipFill>
            <p:spPr>
              <a:xfrm>
                <a:off x="2607840" y="4754520"/>
                <a:ext cx="1024200" cy="1024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4" name="Picture 2" descr=""/>
              <p:cNvPicPr/>
              <p:nvPr/>
            </p:nvPicPr>
            <p:blipFill>
              <a:blip r:embed="rId12"/>
              <a:srcRect l="67588" t="32090" r="1615" b="30415"/>
              <a:stretch/>
            </p:blipFill>
            <p:spPr>
              <a:xfrm>
                <a:off x="2607840" y="6806880"/>
                <a:ext cx="1024200" cy="10242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25" name="TextBox 23"/>
            <p:cNvSpPr/>
            <p:nvPr/>
          </p:nvSpPr>
          <p:spPr>
            <a:xfrm>
              <a:off x="76320" y="4191120"/>
              <a:ext cx="501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123"/>
            <p:cNvSpPr/>
            <p:nvPr/>
          </p:nvSpPr>
          <p:spPr>
            <a:xfrm>
              <a:off x="586440" y="4555080"/>
              <a:ext cx="678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i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123"/>
            <p:cNvSpPr/>
            <p:nvPr/>
          </p:nvSpPr>
          <p:spPr>
            <a:xfrm>
              <a:off x="1774080" y="455508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123"/>
            <p:cNvSpPr/>
            <p:nvPr/>
          </p:nvSpPr>
          <p:spPr>
            <a:xfrm>
              <a:off x="2726280" y="4543200"/>
              <a:ext cx="61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cGAMP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Straight Connector 43"/>
            <p:cNvSpPr/>
            <p:nvPr/>
          </p:nvSpPr>
          <p:spPr>
            <a:xfrm flipH="1">
              <a:off x="1685520" y="4513320"/>
              <a:ext cx="1523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123"/>
            <p:cNvSpPr/>
            <p:nvPr/>
          </p:nvSpPr>
          <p:spPr>
            <a:xfrm>
              <a:off x="2041560" y="4267080"/>
              <a:ext cx="813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sicGAS # 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31" name="Group 7"/>
            <p:cNvGrpSpPr/>
            <p:nvPr/>
          </p:nvGrpSpPr>
          <p:grpSpPr>
            <a:xfrm>
              <a:off x="3088440" y="5638320"/>
              <a:ext cx="517680" cy="2058120"/>
              <a:chOff x="3088440" y="5638320"/>
              <a:chExt cx="517680" cy="2058120"/>
            </a:xfrm>
          </p:grpSpPr>
          <p:grpSp>
            <p:nvGrpSpPr>
              <p:cNvPr id="132" name="Group 45"/>
              <p:cNvGrpSpPr/>
              <p:nvPr/>
            </p:nvGrpSpPr>
            <p:grpSpPr>
              <a:xfrm>
                <a:off x="3088440" y="5638320"/>
                <a:ext cx="517680" cy="1521360"/>
                <a:chOff x="3088440" y="5638320"/>
                <a:chExt cx="517680" cy="1521360"/>
              </a:xfrm>
            </p:grpSpPr>
            <p:sp>
              <p:nvSpPr>
                <p:cNvPr id="133" name="직선 연결선 18"/>
                <p:cNvSpPr/>
                <p:nvPr/>
              </p:nvSpPr>
              <p:spPr>
                <a:xfrm>
                  <a:off x="3367080" y="5638320"/>
                  <a:ext cx="1378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4" name="직선 연결선 17"/>
                <p:cNvSpPr/>
                <p:nvPr/>
              </p:nvSpPr>
              <p:spPr>
                <a:xfrm>
                  <a:off x="3367080" y="6705720"/>
                  <a:ext cx="137880" cy="0"/>
                </a:xfrm>
                <a:prstGeom prst="line">
                  <a:avLst/>
                </a:prstGeom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5" name="TextBox 19"/>
                <p:cNvSpPr/>
                <p:nvPr/>
              </p:nvSpPr>
              <p:spPr>
                <a:xfrm>
                  <a:off x="3088440" y="6806880"/>
                  <a:ext cx="517680" cy="352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900" spc="-1" strike="noStrike">
                      <a:solidFill>
                        <a:srgbClr val="00ff00"/>
                      </a:solidFill>
                      <a:latin typeface="Arial"/>
                      <a:ea typeface="맑은 고딕"/>
                    </a:rPr>
                    <a:t>ᵞ</a:t>
                  </a:r>
                  <a:r>
                    <a:rPr b="0" lang="en-US" sz="800" spc="-1" strike="noStrike">
                      <a:solidFill>
                        <a:srgbClr val="00ff00"/>
                      </a:solidFill>
                      <a:latin typeface="Arial"/>
                      <a:ea typeface="맑은 고딕"/>
                    </a:rPr>
                    <a:t>-H2AX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70c0"/>
                      </a:solidFill>
                      <a:latin typeface="Arial"/>
                      <a:ea typeface="맑은 고딕"/>
                    </a:rPr>
                    <a:t>DAPI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36" name="직선 연결선 17"/>
              <p:cNvSpPr/>
              <p:nvPr/>
            </p:nvSpPr>
            <p:spPr>
              <a:xfrm>
                <a:off x="3367080" y="7696440"/>
                <a:ext cx="137880" cy="0"/>
              </a:xfrm>
              <a:prstGeom prst="line">
                <a:avLst/>
              </a:prstGeom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37" name="Group 5"/>
          <p:cNvGrpSpPr/>
          <p:nvPr/>
        </p:nvGrpSpPr>
        <p:grpSpPr>
          <a:xfrm>
            <a:off x="3624120" y="4232160"/>
            <a:ext cx="2737080" cy="3540600"/>
            <a:chOff x="3624120" y="4232160"/>
            <a:chExt cx="2737080" cy="3540600"/>
          </a:xfrm>
        </p:grpSpPr>
        <p:sp>
          <p:nvSpPr>
            <p:cNvPr id="138" name="TextBox 25"/>
            <p:cNvSpPr/>
            <p:nvPr/>
          </p:nvSpPr>
          <p:spPr>
            <a:xfrm>
              <a:off x="3624120" y="4232160"/>
              <a:ext cx="502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39" name="Group 3"/>
            <p:cNvGrpSpPr/>
            <p:nvPr/>
          </p:nvGrpSpPr>
          <p:grpSpPr>
            <a:xfrm>
              <a:off x="5107680" y="7526520"/>
              <a:ext cx="1067760" cy="246240"/>
              <a:chOff x="5107680" y="7526520"/>
              <a:chExt cx="1067760" cy="246240"/>
            </a:xfrm>
          </p:grpSpPr>
          <p:sp>
            <p:nvSpPr>
              <p:cNvPr id="140" name="Straight Connector 2"/>
              <p:cNvSpPr/>
              <p:nvPr/>
            </p:nvSpPr>
            <p:spPr>
              <a:xfrm flipH="1">
                <a:off x="5107680" y="7526520"/>
                <a:ext cx="1067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TextBox 29"/>
              <p:cNvSpPr/>
              <p:nvPr/>
            </p:nvSpPr>
            <p:spPr>
              <a:xfrm>
                <a:off x="5209560" y="7526520"/>
                <a:ext cx="865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sicGAS # 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42" name="Chart 52" descr=""/>
            <p:cNvPicPr/>
            <p:nvPr/>
          </p:nvPicPr>
          <p:blipFill>
            <a:blip r:embed="rId13"/>
            <a:stretch/>
          </p:blipFill>
          <p:spPr>
            <a:xfrm>
              <a:off x="3657240" y="4961880"/>
              <a:ext cx="2703960" cy="27129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"/>
          <p:cNvSpPr txBox="1"/>
          <p:nvPr/>
        </p:nvSpPr>
        <p:spPr>
          <a:xfrm>
            <a:off x="342720" y="409680"/>
            <a:ext cx="6172200" cy="4091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algn="just">
              <a:lnSpc>
                <a:spcPct val="2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2: cGAS-STING pathway does not affect centrosome amplification or DNA damage. (a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Representative confocal images of a mitotic cell during metaphase showing bipolar orientation of centrosomes (white arrow head) after staining with anti-gamma-tubulin antibody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(b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 Quantification of cells with less than or equal to 2 centrosomes (black bar) or more than 2 centrosomes ( gray bar) after co-transfection with siSTING accompanied with or without ectopic expression of STING wild-type, STING constitutively-active &amp; STING inactive mutant forms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(c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 Representative images of a cell showing gamma-H2A.X foci formation upon staining with gamma-H2A.X antibody after cGAS knock-down with or without cGAMP transfection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(d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 Percentage of cells showing gamma-H2A.X foci formation with or without cGAMP transfection in cGAS-depleted HeLa cells. The results are given as the mean ± SD from three independent experiments (n = 300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직사각형 3"/>
          <p:cNvSpPr/>
          <p:nvPr/>
        </p:nvSpPr>
        <p:spPr>
          <a:xfrm>
            <a:off x="0" y="8532720"/>
            <a:ext cx="6858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 Unicode MS"/>
                <a:ea typeface="맑은 고딕"/>
              </a:rPr>
              <a:t>Supplementary Figure 3. cGAS-depletion induces early mitotic progression resulting in enhanced mitotic defect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5" name="Group 12"/>
          <p:cNvGrpSpPr/>
          <p:nvPr/>
        </p:nvGrpSpPr>
        <p:grpSpPr>
          <a:xfrm>
            <a:off x="299880" y="3908520"/>
            <a:ext cx="6258240" cy="2103480"/>
            <a:chOff x="299880" y="3908520"/>
            <a:chExt cx="6258240" cy="2103480"/>
          </a:xfrm>
        </p:grpSpPr>
        <p:pic>
          <p:nvPicPr>
            <p:cNvPr id="146" name="차트 125" descr=""/>
            <p:cNvPicPr/>
            <p:nvPr/>
          </p:nvPicPr>
          <p:blipFill>
            <a:blip r:embed="rId1"/>
            <a:stretch/>
          </p:blipFill>
          <p:spPr>
            <a:xfrm>
              <a:off x="299880" y="3908520"/>
              <a:ext cx="2742120" cy="2103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7" name="차트 127" descr=""/>
            <p:cNvPicPr/>
            <p:nvPr/>
          </p:nvPicPr>
          <p:blipFill>
            <a:blip r:embed="rId2"/>
            <a:stretch/>
          </p:blipFill>
          <p:spPr>
            <a:xfrm>
              <a:off x="3907440" y="3908520"/>
              <a:ext cx="2650680" cy="2103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48" name="TextBox 13"/>
          <p:cNvSpPr/>
          <p:nvPr/>
        </p:nvSpPr>
        <p:spPr>
          <a:xfrm>
            <a:off x="260280" y="340668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14"/>
          <p:cNvSpPr/>
          <p:nvPr/>
        </p:nvSpPr>
        <p:spPr>
          <a:xfrm>
            <a:off x="4037040" y="3430440"/>
            <a:ext cx="501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0" name="차트 40" descr=""/>
          <p:cNvPicPr/>
          <p:nvPr/>
        </p:nvPicPr>
        <p:blipFill>
          <a:blip r:embed="rId3"/>
          <a:stretch/>
        </p:blipFill>
        <p:spPr>
          <a:xfrm>
            <a:off x="2060640" y="6516720"/>
            <a:ext cx="2736720" cy="2103480"/>
          </a:xfrm>
          <a:prstGeom prst="rect">
            <a:avLst/>
          </a:prstGeom>
          <a:ln w="0">
            <a:noFill/>
          </a:ln>
        </p:spPr>
      </p:pic>
      <p:sp>
        <p:nvSpPr>
          <p:cNvPr id="151" name="Straight Connector 17"/>
          <p:cNvSpPr/>
          <p:nvPr/>
        </p:nvSpPr>
        <p:spPr>
          <a:xfrm flipH="1">
            <a:off x="1413000" y="434196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Straight Connector 18"/>
          <p:cNvSpPr/>
          <p:nvPr/>
        </p:nvSpPr>
        <p:spPr>
          <a:xfrm flipH="1">
            <a:off x="3213000" y="687564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Straight Connector 19"/>
          <p:cNvSpPr/>
          <p:nvPr/>
        </p:nvSpPr>
        <p:spPr>
          <a:xfrm flipH="1">
            <a:off x="5013360" y="491796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20"/>
          <p:cNvSpPr/>
          <p:nvPr/>
        </p:nvSpPr>
        <p:spPr>
          <a:xfrm>
            <a:off x="1413000" y="41371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21"/>
          <p:cNvSpPr/>
          <p:nvPr/>
        </p:nvSpPr>
        <p:spPr>
          <a:xfrm>
            <a:off x="5013360" y="47023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22"/>
          <p:cNvSpPr/>
          <p:nvPr/>
        </p:nvSpPr>
        <p:spPr>
          <a:xfrm>
            <a:off x="3213000" y="665964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23"/>
          <p:cNvSpPr/>
          <p:nvPr/>
        </p:nvSpPr>
        <p:spPr>
          <a:xfrm>
            <a:off x="2060640" y="6084720"/>
            <a:ext cx="50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 Unicode MS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8" name="Group 26"/>
          <p:cNvGrpSpPr/>
          <p:nvPr/>
        </p:nvGrpSpPr>
        <p:grpSpPr>
          <a:xfrm>
            <a:off x="260280" y="328680"/>
            <a:ext cx="6323040" cy="3098880"/>
            <a:chOff x="260280" y="328680"/>
            <a:chExt cx="6323040" cy="3098880"/>
          </a:xfrm>
        </p:grpSpPr>
        <p:sp>
          <p:nvSpPr>
            <p:cNvPr id="159" name="TextBox 5"/>
            <p:cNvSpPr/>
            <p:nvPr/>
          </p:nvSpPr>
          <p:spPr>
            <a:xfrm>
              <a:off x="4005000" y="328680"/>
              <a:ext cx="564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7"/>
            <p:cNvSpPr/>
            <p:nvPr/>
          </p:nvSpPr>
          <p:spPr>
            <a:xfrm>
              <a:off x="260280" y="328680"/>
              <a:ext cx="502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61" name="Group 9"/>
            <p:cNvGrpSpPr/>
            <p:nvPr/>
          </p:nvGrpSpPr>
          <p:grpSpPr>
            <a:xfrm>
              <a:off x="273960" y="683640"/>
              <a:ext cx="6309360" cy="2743920"/>
              <a:chOff x="273960" y="683640"/>
              <a:chExt cx="6309360" cy="2743920"/>
            </a:xfrm>
          </p:grpSpPr>
          <p:graphicFrame>
            <p:nvGraphicFramePr>
              <p:cNvPr id="162" name="Object 1"/>
              <p:cNvGraphicFramePr/>
              <p:nvPr/>
            </p:nvGraphicFramePr>
            <p:xfrm>
              <a:off x="273960" y="683640"/>
              <a:ext cx="2660760" cy="2743920"/>
            </p:xfrm>
            <a:graphic>
              <a:graphicData uri="http://schemas.openxmlformats.org/presentationml/2006/ole">
                <p:oleObj r:id="rId4" spid="">
                  <p:embed/>
                  <p:pic>
                    <p:nvPicPr>
                      <p:cNvPr id="163" name="Object 1" descr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273960" y="683640"/>
                        <a:ext cx="2660760" cy="27439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164" name="Object 2"/>
              <p:cNvGraphicFramePr/>
              <p:nvPr/>
            </p:nvGraphicFramePr>
            <p:xfrm>
              <a:off x="4054680" y="683640"/>
              <a:ext cx="2528640" cy="2743920"/>
            </p:xfrm>
            <a:graphic>
              <a:graphicData uri="http://schemas.openxmlformats.org/presentationml/2006/ole">
                <p:oleObj r:id="rId6" spid="">
                  <p:embed/>
                  <p:pic>
                    <p:nvPicPr>
                      <p:cNvPr id="165" name="Object 2" descr=""/>
                      <p:cNvPicPr/>
                      <p:nvPr/>
                    </p:nvPicPr>
                    <p:blipFill>
                      <a:blip r:embed="rId7"/>
                      <a:stretch/>
                    </p:blipFill>
                    <p:spPr>
                      <a:xfrm>
                        <a:off x="4054680" y="683640"/>
                        <a:ext cx="2528640" cy="274392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</p:grpSp>
        <p:sp>
          <p:nvSpPr>
            <p:cNvPr id="166" name="Straight Connector 6"/>
            <p:cNvSpPr/>
            <p:nvPr/>
          </p:nvSpPr>
          <p:spPr>
            <a:xfrm>
              <a:off x="1268280" y="1260360"/>
              <a:ext cx="1042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Straight Connector 16"/>
            <p:cNvSpPr/>
            <p:nvPr/>
          </p:nvSpPr>
          <p:spPr>
            <a:xfrm>
              <a:off x="5013360" y="1403280"/>
              <a:ext cx="100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24"/>
            <p:cNvSpPr/>
            <p:nvPr/>
          </p:nvSpPr>
          <p:spPr>
            <a:xfrm>
              <a:off x="5013000" y="1199160"/>
              <a:ext cx="100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TextBox 25"/>
            <p:cNvSpPr/>
            <p:nvPr/>
          </p:nvSpPr>
          <p:spPr>
            <a:xfrm>
              <a:off x="1268280" y="1054800"/>
              <a:ext cx="104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**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"/>
          <p:cNvSpPr txBox="1"/>
          <p:nvPr/>
        </p:nvSpPr>
        <p:spPr>
          <a:xfrm>
            <a:off x="342720" y="409320"/>
            <a:ext cx="6172200" cy="459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algn="just">
              <a:lnSpc>
                <a:spcPct val="200000"/>
              </a:lnSpc>
              <a:spcBef>
                <a:spcPts val="2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3: cGAS-depletion induces early mitotic progression resulting in enhanced mitotic defects. (a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 Depletion of cGAS using RNA interference and then comparing mitotic duration of siControl- or sicGAS-transfected cells by time-lapse analysis. The results are given as the mean ± SD from three independent experiments (n = 300). ***P &lt; 0.001 by Student’s t-test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(b)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Determining time interval from mitosis onset to metaphase in siControl- or sicGAS-transfected cells by time-lapse analysis. The results are given as the mean ± SD from three independent experiments (n = 300). ***P &lt; 0.001 by Student’s t-test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(c &amp; d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 Quantification of cells undergoing mitotic defects i.e. cytokinesis failure &amp; mitotic slippage after cGAS-depletion via siRNA transfection and release from nocodazole treatment after 16 h. The results are given as the mean ± SD from three independent experiments (n = 300). ***P &lt; 0.001 by Student’s t-test.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 (e)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 Percentage of cells showing cell death in cGAS-positive and cGAS-negative cells after release from nocodazole treatment for 16 h. The results are given as the mean ± SD from three independent experiments (n = 300). ***P &lt; 0.001 by Student’s t-test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0-01T04:43:48Z</dcterms:created>
  <dc:creator>HP-PC</dc:creator>
  <dc:description/>
  <dc:language>en-US</dc:language>
  <cp:lastModifiedBy>HP-PC</cp:lastModifiedBy>
  <dcterms:modified xsi:type="dcterms:W3CDTF">2019-12-23T10:58:45Z</dcterms:modified>
  <cp:revision>6</cp:revision>
  <dc:subject/>
  <dc:title>PowerPoint Presentation</dc:title>
</cp:coreProperties>
</file>